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3BBD4E6F-FE2D-4FB8-891A-A73A7F7F15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045" y="6614497"/>
            <a:ext cx="2944115" cy="213923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AEDD5583-FB88-4165-AF72-497BDC4446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9545" y="6614497"/>
            <a:ext cx="2944115" cy="213923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A435F4B-E95E-43E4-A8BE-F40A462221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946" y="2274786"/>
            <a:ext cx="2820828" cy="204964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D966E784-7ED8-415B-9947-4FC0E07D86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1396" y="2274786"/>
            <a:ext cx="2820828" cy="204964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0746E83-F90D-4882-9F3E-56AB9AC27F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1454" y="4544911"/>
            <a:ext cx="2802270" cy="203616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54F69758-6362-46FD-A049-04D48EB4505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60429" y="4544911"/>
            <a:ext cx="2802270" cy="2036163"/>
          </a:xfrm>
          <a:prstGeom prst="rect">
            <a:avLst/>
          </a:prstGeom>
        </p:spPr>
      </p:pic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3BDB9BD5-C8E3-43D4-B8A2-0582A9D6BFA7}"/>
              </a:ext>
            </a:extLst>
          </p:cNvPr>
          <p:cNvSpPr txBox="1"/>
          <p:nvPr/>
        </p:nvSpPr>
        <p:spPr>
          <a:xfrm rot="16200000">
            <a:off x="2876215" y="74691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A4F0FA59-45A1-4E98-B8A1-306606E1F8C8}"/>
              </a:ext>
            </a:extLst>
          </p:cNvPr>
          <p:cNvSpPr txBox="1"/>
          <p:nvPr/>
        </p:nvSpPr>
        <p:spPr>
          <a:xfrm>
            <a:off x="5211586" y="85838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F3384F79-7FA6-4535-904C-B5F49879D8CA}"/>
              </a:ext>
            </a:extLst>
          </p:cNvPr>
          <p:cNvSpPr txBox="1"/>
          <p:nvPr/>
        </p:nvSpPr>
        <p:spPr>
          <a:xfrm>
            <a:off x="1432560" y="6955066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4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.5 (5.03: 2.25-11.2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09: 0.03-0.3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47: 1.21-1.7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33: 0.19-0.5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6CBEF530-EA7E-448D-95E6-0722AB464A4A}"/>
              </a:ext>
            </a:extLst>
          </p:cNvPr>
          <p:cNvSpPr txBox="1"/>
          <p:nvPr/>
        </p:nvSpPr>
        <p:spPr>
          <a:xfrm rot="16200000">
            <a:off x="-333005" y="74691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00B4391C-F42F-4EAC-8746-C2E28C83FCBB}"/>
              </a:ext>
            </a:extLst>
          </p:cNvPr>
          <p:cNvSpPr txBox="1"/>
          <p:nvPr/>
        </p:nvSpPr>
        <p:spPr>
          <a:xfrm>
            <a:off x="2002366" y="85838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542BA411-0B4F-445E-A6F4-6FA6C5C0EE08}"/>
              </a:ext>
            </a:extLst>
          </p:cNvPr>
          <p:cNvSpPr txBox="1"/>
          <p:nvPr/>
        </p:nvSpPr>
        <p:spPr>
          <a:xfrm>
            <a:off x="4661535" y="6955066"/>
            <a:ext cx="20286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43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.5 (5.82: 2.37-14.29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07: 0.02-0.28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53: 1.23-1.8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30: 0.16-0.5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51E3ACA9-5BB7-4782-9327-30B4238467B6}"/>
              </a:ext>
            </a:extLst>
          </p:cNvPr>
          <p:cNvSpPr txBox="1"/>
          <p:nvPr/>
        </p:nvSpPr>
        <p:spPr>
          <a:xfrm rot="16200000">
            <a:off x="2876215" y="52974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95DB996-9A55-4C9E-9BDD-BC2CCAEB87BF}"/>
              </a:ext>
            </a:extLst>
          </p:cNvPr>
          <p:cNvSpPr txBox="1"/>
          <p:nvPr/>
        </p:nvSpPr>
        <p:spPr>
          <a:xfrm>
            <a:off x="5211586" y="64349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40EA1CAF-0858-45C5-9918-FA0ECDC7A8D1}"/>
              </a:ext>
            </a:extLst>
          </p:cNvPr>
          <p:cNvSpPr txBox="1"/>
          <p:nvPr/>
        </p:nvSpPr>
        <p:spPr>
          <a:xfrm>
            <a:off x="1436370" y="4716691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5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6 (2.29: 1.14-4.6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44: 0.22-0.88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19: 1.03-1.3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66: 0.46-0.94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CE2BB55E-A3E9-40C8-B24A-5C64DFC8786B}"/>
              </a:ext>
            </a:extLst>
          </p:cNvPr>
          <p:cNvSpPr txBox="1"/>
          <p:nvPr/>
        </p:nvSpPr>
        <p:spPr>
          <a:xfrm rot="16200000">
            <a:off x="-333005" y="52974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27352884-A639-4293-A629-16E9FD0BBB01}"/>
              </a:ext>
            </a:extLst>
          </p:cNvPr>
          <p:cNvSpPr txBox="1"/>
          <p:nvPr/>
        </p:nvSpPr>
        <p:spPr>
          <a:xfrm>
            <a:off x="2002366" y="64349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7998AFC9-D449-42A5-A2E0-7A3B684EFE5B}"/>
              </a:ext>
            </a:extLst>
          </p:cNvPr>
          <p:cNvSpPr txBox="1"/>
          <p:nvPr/>
        </p:nvSpPr>
        <p:spPr>
          <a:xfrm>
            <a:off x="4595341" y="4716691"/>
            <a:ext cx="20286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4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6 (2.31: 1.07-4.95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36.5 (0.43: 0.20-0.93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5 (1.19: 1.02-1.3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26.5 (0.66: 0.45-0.9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F7725676-C2EA-4AE8-B18B-EB66166D0570}"/>
              </a:ext>
            </a:extLst>
          </p:cNvPr>
          <p:cNvSpPr txBox="1"/>
          <p:nvPr/>
        </p:nvSpPr>
        <p:spPr>
          <a:xfrm rot="16200000">
            <a:off x="2876215" y="3034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5306F156-1DD8-4820-94C8-5C613837D174}"/>
              </a:ext>
            </a:extLst>
          </p:cNvPr>
          <p:cNvSpPr txBox="1"/>
          <p:nvPr/>
        </p:nvSpPr>
        <p:spPr>
          <a:xfrm>
            <a:off x="5211586" y="417184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AE6A444A-7FB0-4C3A-9720-067BA34F9D8B}"/>
              </a:ext>
            </a:extLst>
          </p:cNvPr>
          <p:cNvSpPr txBox="1"/>
          <p:nvPr/>
        </p:nvSpPr>
        <p:spPr>
          <a:xfrm>
            <a:off x="1514475" y="2482126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1 (1.89: 1.01-3.5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9 (0.31: 0.10-0.98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5.5 (1.10: 1.00-1.2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59: 0.36-0.9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DAE4D65-0F5E-4803-A7B9-CE177FF0DC3E}"/>
              </a:ext>
            </a:extLst>
          </p:cNvPr>
          <p:cNvSpPr txBox="1"/>
          <p:nvPr/>
        </p:nvSpPr>
        <p:spPr>
          <a:xfrm rot="16200000">
            <a:off x="-333005" y="3034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AB441C25-0817-4861-AB59-59B125E51EBC}"/>
              </a:ext>
            </a:extLst>
          </p:cNvPr>
          <p:cNvSpPr txBox="1"/>
          <p:nvPr/>
        </p:nvSpPr>
        <p:spPr>
          <a:xfrm>
            <a:off x="2002366" y="417184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935C410D-CC77-4FC2-89F3-622ACABA5492}"/>
              </a:ext>
            </a:extLst>
          </p:cNvPr>
          <p:cNvSpPr txBox="1"/>
          <p:nvPr/>
        </p:nvSpPr>
        <p:spPr>
          <a:xfrm>
            <a:off x="4239399" y="2547798"/>
            <a:ext cx="26080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5.5 (1.07: 0.96-1.18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70: 0.40-1.2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9" name="図 148">
            <a:extLst>
              <a:ext uri="{FF2B5EF4-FFF2-40B4-BE49-F238E27FC236}">
                <a16:creationId xmlns:a16="http://schemas.microsoft.com/office/drawing/2014/main" id="{1AE225CA-6A63-43A3-9BF0-3F03FDB0C4C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0058" y="150218"/>
            <a:ext cx="2813191" cy="2044099"/>
          </a:xfrm>
          <a:prstGeom prst="rect">
            <a:avLst/>
          </a:prstGeom>
        </p:spPr>
      </p:pic>
      <p:pic>
        <p:nvPicPr>
          <p:cNvPr id="150" name="図 149">
            <a:extLst>
              <a:ext uri="{FF2B5EF4-FFF2-40B4-BE49-F238E27FC236}">
                <a16:creationId xmlns:a16="http://schemas.microsoft.com/office/drawing/2014/main" id="{208F4F5F-26F9-4FA3-8381-55351728AD9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41888" y="150218"/>
            <a:ext cx="2813191" cy="2044099"/>
          </a:xfrm>
          <a:prstGeom prst="rect">
            <a:avLst/>
          </a:prstGeom>
        </p:spPr>
      </p:pic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19818D32-D44A-4BE5-A2D3-54FFB281F388}"/>
              </a:ext>
            </a:extLst>
          </p:cNvPr>
          <p:cNvSpPr txBox="1"/>
          <p:nvPr/>
        </p:nvSpPr>
        <p:spPr>
          <a:xfrm rot="16200000">
            <a:off x="2876215" y="91973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CDC069C3-5666-4E33-B351-1D57420301FA}"/>
              </a:ext>
            </a:extLst>
          </p:cNvPr>
          <p:cNvSpPr txBox="1"/>
          <p:nvPr/>
        </p:nvSpPr>
        <p:spPr>
          <a:xfrm>
            <a:off x="5211586" y="205729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0A74C8CD-641C-473A-96C9-5D14466389CC}"/>
              </a:ext>
            </a:extLst>
          </p:cNvPr>
          <p:cNvSpPr txBox="1"/>
          <p:nvPr/>
        </p:nvSpPr>
        <p:spPr>
          <a:xfrm>
            <a:off x="1514475" y="339001"/>
            <a:ext cx="19607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4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4 (1.83: 1.10-3.06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9 (0.26: 0.08-0.8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6 (1.09: 1.01-1.1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54: 0.33-0.91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1FCBBABA-7EB4-40A6-839E-EEDE42F2EF25}"/>
              </a:ext>
            </a:extLst>
          </p:cNvPr>
          <p:cNvSpPr txBox="1"/>
          <p:nvPr/>
        </p:nvSpPr>
        <p:spPr>
          <a:xfrm rot="16200000">
            <a:off x="-333005" y="91973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AB4F30E5-5BD5-4048-8E8E-841649CA5B2E}"/>
              </a:ext>
            </a:extLst>
          </p:cNvPr>
          <p:cNvSpPr txBox="1"/>
          <p:nvPr/>
        </p:nvSpPr>
        <p:spPr>
          <a:xfrm>
            <a:off x="2002366" y="205729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GS (kg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9E8DB3A1-ED3D-4789-AE8B-0971B5626CED}"/>
              </a:ext>
            </a:extLst>
          </p:cNvPr>
          <p:cNvSpPr txBox="1"/>
          <p:nvPr/>
        </p:nvSpPr>
        <p:spPr>
          <a:xfrm>
            <a:off x="4714169" y="357065"/>
            <a:ext cx="20357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5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4 (1.74: 1.01-3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59 (0.29: 0.09-0.99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26 (1.08: 1.00-1.1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42 (0.58: 0.33-0.9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3539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HGS with incident disability and mortality risks, excluding disabilities or deaths that occurred during the first year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195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252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742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1</TotalTime>
  <Words>657</Words>
  <Application>Microsoft Office PowerPoint</Application>
  <PresentationFormat>画面に合わせる (4:3)</PresentationFormat>
  <Paragraphs>9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48</cp:revision>
  <cp:lastPrinted>2019-04-05T09:48:00Z</cp:lastPrinted>
  <dcterms:created xsi:type="dcterms:W3CDTF">2019-01-07T07:45:10Z</dcterms:created>
  <dcterms:modified xsi:type="dcterms:W3CDTF">2022-02-10T10:03:17Z</dcterms:modified>
</cp:coreProperties>
</file>